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notesSlides/notesSlide1.xml" ContentType="application/vnd.openxmlformats-officedocument.presentationml.notesSlide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6" r:id="rId2"/>
    <p:sldId id="257" r:id="rId3"/>
    <p:sldId id="261" r:id="rId4"/>
    <p:sldId id="259" r:id="rId5"/>
    <p:sldId id="262" r:id="rId6"/>
    <p:sldId id="265" r:id="rId7"/>
    <p:sldId id="267" r:id="rId8"/>
    <p:sldId id="269" r:id="rId9"/>
    <p:sldId id="268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13" autoAdjust="0"/>
    <p:restoredTop sz="94660"/>
  </p:normalViewPr>
  <p:slideViewPr>
    <p:cSldViewPr snapToGrid="0">
      <p:cViewPr varScale="1">
        <p:scale>
          <a:sx n="84" d="100"/>
          <a:sy n="84" d="100"/>
        </p:scale>
        <p:origin x="9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4FC49B-C802-4A27-8508-641CEE448963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8A64F1-0A76-402A-B3A2-8D3A4C0CF00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94505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D8A64F1-0A76-402A-B3A2-8D3A4C0CF00D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36550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9A3A34-A367-1122-D2E5-13A15514E6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14998D3-ABB5-C59F-36B4-0E5DDB3A50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3FCE70E-AE42-5A1E-DB12-FEF496A1A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A1A8E5-CE37-842B-A761-A7167B7B4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015FD6-7A14-5AC2-6621-F4761972B0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2725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301E2D-4F82-0FF1-C778-44EABABA71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5D636E1-9947-A80A-C281-F1DE847F00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9D50933-4BFD-19A5-734A-A8AF35BAF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0549CF4-7655-F045-2C5D-5AE45E9C60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5F7DBC-A066-AD68-472A-5DE69872B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8831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074878E-F61C-F4CE-838F-D3BF972A4A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85D1B57-1EAB-866C-2F92-E45D92649E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31BAC06-15BD-6142-664E-459816C73A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97C8CEF-0FCC-C188-6D90-29042E369A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D83855-4849-8955-E658-A85918E82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7383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01195C-C7FD-3625-BD2C-82E269A05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C41BDEB-0DDA-8E9E-81B3-9D3CE76DD8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BE456B-ED0E-C9E2-AB15-951809A78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948443-1305-867D-65C0-AC33E753F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954A78-4B53-31CC-3ED3-A85957A47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1895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5996D0B-3C93-0313-01A4-74B78E832A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3FF72BB-703C-3B2C-D07D-D23E1D50DE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EBF5085-0822-5BD4-9C0B-97595A9D59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B59055-3BCE-1FA0-42F1-2C32B3BDD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AD93879-2A37-D05F-025E-2420F57E4E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14149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4692CED-3183-009A-E519-EB6DFAFAAD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032D007-AFCD-8A8C-3F94-32F9C34FD7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7E7E95C-84B3-275B-C3A0-C41EAAA30F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3FB3A66-1113-B981-F6C8-78BC4933E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673992-2FD2-D1CA-C317-2C17A851C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FDF05A7-FB7F-61E8-1B0E-12FFD7DAE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665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FB8F28-635D-0432-A7E0-DBD277937D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253A05F-6CED-4F4D-D28F-5F73DA395D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448263A-038D-CBFE-A972-A2E293D49A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B5CC260-1230-77CA-1684-90B462BAC9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F3709BE-388B-5055-D6C6-5772D514C1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1970602-D966-5107-23F4-AB6A04902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E46E49B-0B46-896C-C53B-33447E6F1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5E6D1F5E-9BAC-4739-D669-DFC60EBDB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46528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14B5B8-9C3E-1E11-DF5F-69F9452304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FAEEF55-DBCA-7A6D-696E-2944E7A5E5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01E166D-3FD1-83BC-29BB-22B550F95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27652B2F-6484-942F-896F-0E49D74CC3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72547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942C8DF-66AD-461A-4BA2-0E96CC761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4AB7EFB-CD6A-FBDD-F7D1-624F68A97E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290D275-3FE5-839F-CB14-B22A38A79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71841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DDC01D0-E838-AD68-C57D-6B302BB7DE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0D8782-91D4-472F-2D6D-8D598802E0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2759715-4C5E-2025-BB6F-E438586B83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14E52F9-182D-A308-1EE6-9CF5F113D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C29F75-A8A2-DE25-0E87-EA409DFBA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02FF993-6A86-2A10-D089-BB305A702A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4337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0D71A6-E135-9DDE-7F02-92AE535EE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80B8866-B7A2-EEF6-A29C-5F017013D8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C859514-D7A5-003D-EDE2-EA58087AFC3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25D5B9-8B99-28E1-1F36-489A4EA5A0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6D9F7E4-933D-65B0-BC65-44F0202E1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B85A76A-5B10-5C93-99AE-546AA1FEA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4740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74F896F-24FA-87D4-60A7-A2591D6C81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804A7B3-256C-92AB-195A-E06300E28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D5E75A7-94FE-3BA8-CC1C-3C1AF16CBBB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9B34C9-7608-4D22-82CB-E95C4060B7C5}" type="datetimeFigureOut">
              <a:rPr lang="zh-CN" altLang="en-US" smtClean="0"/>
              <a:t>2025/11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AE2EDC9-37B0-FE35-29C3-67F65F44F6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ADE821-BEB2-9EA5-6289-F1E5CAA6A0D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876B5-FBE5-4C4C-9F78-66F5EEE61C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8295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7" Type="http://schemas.openxmlformats.org/officeDocument/2006/relationships/image" Target="../media/image17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Relationship Id="rId6" Type="http://schemas.openxmlformats.org/officeDocument/2006/relationships/image" Target="../media/image16.jpeg"/><Relationship Id="rId5" Type="http://schemas.openxmlformats.org/officeDocument/2006/relationships/image" Target="../media/image15.jpeg"/><Relationship Id="rId4" Type="http://schemas.openxmlformats.org/officeDocument/2006/relationships/image" Target="../media/image14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jpeg"/><Relationship Id="rId4" Type="http://schemas.openxmlformats.org/officeDocument/2006/relationships/image" Target="../media/image20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jpeg"/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6.jpeg"/><Relationship Id="rId5" Type="http://schemas.openxmlformats.org/officeDocument/2006/relationships/image" Target="../media/image25.jpeg"/><Relationship Id="rId4" Type="http://schemas.openxmlformats.org/officeDocument/2006/relationships/image" Target="../media/image24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9.jpeg"/><Relationship Id="rId4" Type="http://schemas.openxmlformats.org/officeDocument/2006/relationships/image" Target="../media/image28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Relationship Id="rId4" Type="http://schemas.openxmlformats.org/officeDocument/2006/relationships/image" Target="../media/image31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jpeg"/><Relationship Id="rId2" Type="http://schemas.openxmlformats.org/officeDocument/2006/relationships/image" Target="../media/image3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文本框 17">
            <a:extLst>
              <a:ext uri="{FF2B5EF4-FFF2-40B4-BE49-F238E27FC236}">
                <a16:creationId xmlns:a16="http://schemas.microsoft.com/office/drawing/2014/main" id="{3DB498F7-8D21-2210-09FE-8E4EEF96BFA1}"/>
              </a:ext>
            </a:extLst>
          </p:cNvPr>
          <p:cNvSpPr txBox="1"/>
          <p:nvPr/>
        </p:nvSpPr>
        <p:spPr>
          <a:xfrm>
            <a:off x="747645" y="309563"/>
            <a:ext cx="109998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1 </a:t>
            </a:r>
          </a:p>
          <a:p>
            <a:endParaRPr lang="en-US" altLang="zh-CN" b="1" dirty="0"/>
          </a:p>
        </p:txBody>
      </p:sp>
      <p:pic>
        <p:nvPicPr>
          <p:cNvPr id="19" name="图片 18" descr="1125 actin1 2020.11.25_21.02.37_Ch+Marker">
            <a:extLst>
              <a:ext uri="{FF2B5EF4-FFF2-40B4-BE49-F238E27FC236}">
                <a16:creationId xmlns:a16="http://schemas.microsoft.com/office/drawing/2014/main" id="{EBD074F3-EF59-0437-8861-496559A98C9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309" t="15270" r="9624" b="70828"/>
          <a:stretch>
            <a:fillRect/>
          </a:stretch>
        </p:blipFill>
        <p:spPr>
          <a:xfrm>
            <a:off x="1245316" y="2135940"/>
            <a:ext cx="4241676" cy="1230078"/>
          </a:xfrm>
          <a:prstGeom prst="rect">
            <a:avLst/>
          </a:prstGeom>
        </p:spPr>
      </p:pic>
      <p:sp>
        <p:nvSpPr>
          <p:cNvPr id="20" name="文本框 24">
            <a:extLst>
              <a:ext uri="{FF2B5EF4-FFF2-40B4-BE49-F238E27FC236}">
                <a16:creationId xmlns:a16="http://schemas.microsoft.com/office/drawing/2014/main" id="{91704FE0-8363-DE1E-9A0B-9BFC5E4EE767}"/>
              </a:ext>
            </a:extLst>
          </p:cNvPr>
          <p:cNvSpPr txBox="1"/>
          <p:nvPr/>
        </p:nvSpPr>
        <p:spPr>
          <a:xfrm>
            <a:off x="197090" y="2704045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/>
              <a:t>β-actin</a:t>
            </a:r>
          </a:p>
        </p:txBody>
      </p:sp>
      <p:pic>
        <p:nvPicPr>
          <p:cNvPr id="23" name="图片 22" descr="1125 phb2 2 2020.11.25_21.13.27_Ch+Marker">
            <a:extLst>
              <a:ext uri="{FF2B5EF4-FFF2-40B4-BE49-F238E27FC236}">
                <a16:creationId xmlns:a16="http://schemas.microsoft.com/office/drawing/2014/main" id="{D226FBEC-57C1-8240-A3AD-38922BA8DFC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661" t="8333" r="3203" b="75383"/>
          <a:stretch>
            <a:fillRect/>
          </a:stretch>
        </p:blipFill>
        <p:spPr>
          <a:xfrm>
            <a:off x="1245315" y="3366018"/>
            <a:ext cx="4241677" cy="1436701"/>
          </a:xfrm>
          <a:prstGeom prst="rect">
            <a:avLst/>
          </a:prstGeom>
        </p:spPr>
      </p:pic>
      <p:sp>
        <p:nvSpPr>
          <p:cNvPr id="25" name="文本框 28">
            <a:extLst>
              <a:ext uri="{FF2B5EF4-FFF2-40B4-BE49-F238E27FC236}">
                <a16:creationId xmlns:a16="http://schemas.microsoft.com/office/drawing/2014/main" id="{4F2D53D0-6B95-BBFA-8D55-16CBE8501C14}"/>
              </a:ext>
            </a:extLst>
          </p:cNvPr>
          <p:cNvSpPr txBox="1"/>
          <p:nvPr/>
        </p:nvSpPr>
        <p:spPr>
          <a:xfrm>
            <a:off x="218942" y="3839287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/>
              <a:t>PHB2</a:t>
            </a: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5F1862C7-25A7-59EC-7CEA-A189F8C9BBAE}"/>
              </a:ext>
            </a:extLst>
          </p:cNvPr>
          <p:cNvSpPr/>
          <p:nvPr/>
        </p:nvSpPr>
        <p:spPr>
          <a:xfrm>
            <a:off x="1945029" y="2420119"/>
            <a:ext cx="2472855" cy="874644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EB82C49B-B159-DF64-7C47-55D33D42B91E}"/>
              </a:ext>
            </a:extLst>
          </p:cNvPr>
          <p:cNvSpPr/>
          <p:nvPr/>
        </p:nvSpPr>
        <p:spPr>
          <a:xfrm>
            <a:off x="1897323" y="3578942"/>
            <a:ext cx="2433098" cy="874644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2C8BE4D-83C1-32EF-E7A4-0A1949D23D4E}"/>
              </a:ext>
            </a:extLst>
          </p:cNvPr>
          <p:cNvSpPr txBox="1"/>
          <p:nvPr/>
        </p:nvSpPr>
        <p:spPr>
          <a:xfrm>
            <a:off x="6096000" y="2867740"/>
            <a:ext cx="16531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Tubulin</a:t>
            </a:r>
            <a:endParaRPr lang="zh-CN" altLang="en-US" b="1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0073C40C-0287-F681-5453-F4E15C93184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8" t="44078" r="28060" b="41855"/>
          <a:stretch>
            <a:fillRect/>
          </a:stretch>
        </p:blipFill>
        <p:spPr>
          <a:xfrm>
            <a:off x="7290703" y="3429000"/>
            <a:ext cx="4047309" cy="111010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704064DD-9D67-8F4F-7D8C-6BDA922ECF52}"/>
              </a:ext>
            </a:extLst>
          </p:cNvPr>
          <p:cNvSpPr txBox="1"/>
          <p:nvPr/>
        </p:nvSpPr>
        <p:spPr>
          <a:xfrm>
            <a:off x="6150969" y="3832874"/>
            <a:ext cx="12813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PHB2</a:t>
            </a:r>
            <a:endParaRPr lang="zh-CN" altLang="en-US" b="1" dirty="0"/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A12CCF1-27CF-95B3-11BA-61E073F782C7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3000" contrast="-4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44" t="43955" r="24110" b="44987"/>
          <a:stretch>
            <a:fillRect/>
          </a:stretch>
        </p:blipFill>
        <p:spPr>
          <a:xfrm>
            <a:off x="7290704" y="2556250"/>
            <a:ext cx="4047309" cy="872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25731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图片 14" descr="0112 bcl2 2 2021.01.13_16.31.37_Ch+Marker">
            <a:extLst>
              <a:ext uri="{FF2B5EF4-FFF2-40B4-BE49-F238E27FC236}">
                <a16:creationId xmlns:a16="http://schemas.microsoft.com/office/drawing/2014/main" id="{E3F7206D-86CB-E571-8771-F5D5181CDDF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9694" t="17490" r="-16701" b="64656"/>
          <a:stretch>
            <a:fillRect/>
          </a:stretch>
        </p:blipFill>
        <p:spPr>
          <a:xfrm>
            <a:off x="3499993" y="1218014"/>
            <a:ext cx="5425438" cy="1372973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85E55BD-622A-7C70-6285-28CFB302523E}"/>
              </a:ext>
            </a:extLst>
          </p:cNvPr>
          <p:cNvSpPr txBox="1"/>
          <p:nvPr/>
        </p:nvSpPr>
        <p:spPr>
          <a:xfrm>
            <a:off x="721519" y="614363"/>
            <a:ext cx="11913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2A</a:t>
            </a:r>
          </a:p>
        </p:txBody>
      </p:sp>
      <p:pic>
        <p:nvPicPr>
          <p:cNvPr id="24" name="图片 23" descr="1125 bax 2 2020.11.25_21.39.55_Ch+Marker">
            <a:extLst>
              <a:ext uri="{FF2B5EF4-FFF2-40B4-BE49-F238E27FC236}">
                <a16:creationId xmlns:a16="http://schemas.microsoft.com/office/drawing/2014/main" id="{66D0817E-32CE-F8A4-3F51-B2045DB83660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1314" t="7764" r="-1179" b="72730"/>
          <a:stretch>
            <a:fillRect/>
          </a:stretch>
        </p:blipFill>
        <p:spPr>
          <a:xfrm>
            <a:off x="3654634" y="3640733"/>
            <a:ext cx="4871057" cy="129796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4E67CC52-9B98-72B6-FF1B-65310A18698B}"/>
              </a:ext>
            </a:extLst>
          </p:cNvPr>
          <p:cNvSpPr txBox="1"/>
          <p:nvPr/>
        </p:nvSpPr>
        <p:spPr>
          <a:xfrm>
            <a:off x="2617834" y="4194431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ax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3059C8FD-824B-6B08-2048-A8AEE6CE20BA}"/>
              </a:ext>
            </a:extLst>
          </p:cNvPr>
          <p:cNvSpPr/>
          <p:nvPr/>
        </p:nvSpPr>
        <p:spPr>
          <a:xfrm>
            <a:off x="4309609" y="3785353"/>
            <a:ext cx="2869344" cy="874644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88D02C6-E915-7E5D-F795-A1A1BD2BDC96}"/>
              </a:ext>
            </a:extLst>
          </p:cNvPr>
          <p:cNvSpPr txBox="1"/>
          <p:nvPr/>
        </p:nvSpPr>
        <p:spPr>
          <a:xfrm>
            <a:off x="2528869" y="1841043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cl-2</a:t>
            </a:r>
          </a:p>
        </p:txBody>
      </p:sp>
      <p:pic>
        <p:nvPicPr>
          <p:cNvPr id="25" name="图片 24" descr="0111cas3 2021.01.11_17.40.36_Ch+Marker">
            <a:extLst>
              <a:ext uri="{FF2B5EF4-FFF2-40B4-BE49-F238E27FC236}">
                <a16:creationId xmlns:a16="http://schemas.microsoft.com/office/drawing/2014/main" id="{5083BA12-CFA4-5E27-5AA3-E6E3700B13F4}"/>
              </a:ext>
            </a:extLst>
          </p:cNvPr>
          <p:cNvPicPr>
            <a:picLocks noChangeAspect="1"/>
          </p:cNvPicPr>
          <p:nvPr/>
        </p:nvPicPr>
        <p:blipFill>
          <a:blip r:embed="rId4">
            <a:lum contrast="-6000"/>
          </a:blip>
          <a:srcRect l="14479" t="15967" r="-8822" b="70438"/>
          <a:stretch>
            <a:fillRect/>
          </a:stretch>
        </p:blipFill>
        <p:spPr>
          <a:xfrm>
            <a:off x="3654634" y="2511876"/>
            <a:ext cx="5425438" cy="1049746"/>
          </a:xfrm>
          <a:prstGeom prst="rect">
            <a:avLst/>
          </a:prstGeom>
        </p:spPr>
      </p:pic>
      <p:sp>
        <p:nvSpPr>
          <p:cNvPr id="27" name="文本框 26">
            <a:extLst>
              <a:ext uri="{FF2B5EF4-FFF2-40B4-BE49-F238E27FC236}">
                <a16:creationId xmlns:a16="http://schemas.microsoft.com/office/drawing/2014/main" id="{28B7C590-AE82-2732-5A35-6B97E2392D89}"/>
              </a:ext>
            </a:extLst>
          </p:cNvPr>
          <p:cNvSpPr txBox="1"/>
          <p:nvPr/>
        </p:nvSpPr>
        <p:spPr>
          <a:xfrm>
            <a:off x="2502419" y="3110070"/>
            <a:ext cx="790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Cas-3</a:t>
            </a: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5F7E419C-339F-3D33-4428-223AF20D8065}"/>
              </a:ext>
            </a:extLst>
          </p:cNvPr>
          <p:cNvSpPr/>
          <p:nvPr/>
        </p:nvSpPr>
        <p:spPr>
          <a:xfrm>
            <a:off x="4359393" y="1571195"/>
            <a:ext cx="2819560" cy="73635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B6EDFCE9-153F-F0D0-C050-07F7C37CC7A6}"/>
              </a:ext>
            </a:extLst>
          </p:cNvPr>
          <p:cNvSpPr/>
          <p:nvPr/>
        </p:nvSpPr>
        <p:spPr>
          <a:xfrm>
            <a:off x="4305059" y="2708128"/>
            <a:ext cx="2873894" cy="73635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8" name="图片 7" descr="0117 actin 2-1 2021.01.17_17.42.42_Ch+Marker">
            <a:extLst>
              <a:ext uri="{FF2B5EF4-FFF2-40B4-BE49-F238E27FC236}">
                <a16:creationId xmlns:a16="http://schemas.microsoft.com/office/drawing/2014/main" id="{9E3F70BF-9C9F-3429-8CFA-57F04004DE9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8504" t="11154" r="-4434" b="75899"/>
          <a:stretch>
            <a:fillRect/>
          </a:stretch>
        </p:blipFill>
        <p:spPr>
          <a:xfrm>
            <a:off x="3654634" y="4938702"/>
            <a:ext cx="4871057" cy="100925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0A9A1BED-3665-EA72-C381-EA2A8C1192D6}"/>
              </a:ext>
            </a:extLst>
          </p:cNvPr>
          <p:cNvSpPr txBox="1"/>
          <p:nvPr/>
        </p:nvSpPr>
        <p:spPr>
          <a:xfrm>
            <a:off x="2502419" y="5094126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β-actin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238A0EA8-5712-15EE-9EC3-108D98442FC4}"/>
              </a:ext>
            </a:extLst>
          </p:cNvPr>
          <p:cNvSpPr/>
          <p:nvPr/>
        </p:nvSpPr>
        <p:spPr>
          <a:xfrm>
            <a:off x="4305059" y="5017813"/>
            <a:ext cx="2757592" cy="874644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97785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465F99-C99B-5B45-D35D-5A607380B9C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>
            <a:extLst>
              <a:ext uri="{FF2B5EF4-FFF2-40B4-BE49-F238E27FC236}">
                <a16:creationId xmlns:a16="http://schemas.microsoft.com/office/drawing/2014/main" id="{7859845F-B7BE-4D10-5D1D-439693898231}"/>
              </a:ext>
            </a:extLst>
          </p:cNvPr>
          <p:cNvSpPr txBox="1"/>
          <p:nvPr/>
        </p:nvSpPr>
        <p:spPr>
          <a:xfrm>
            <a:off x="742950" y="671513"/>
            <a:ext cx="1178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2C</a:t>
            </a:r>
            <a:endParaRPr lang="zh-CN" altLang="en-US" b="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3E65A596-49F8-8D90-A97A-62E359FCDDC3}"/>
              </a:ext>
            </a:extLst>
          </p:cNvPr>
          <p:cNvSpPr txBox="1"/>
          <p:nvPr/>
        </p:nvSpPr>
        <p:spPr>
          <a:xfrm>
            <a:off x="3204774" y="5306536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β-actin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5F58454-4ADC-E596-F100-6AB1E9FABEEC}"/>
              </a:ext>
            </a:extLst>
          </p:cNvPr>
          <p:cNvSpPr txBox="1"/>
          <p:nvPr/>
        </p:nvSpPr>
        <p:spPr>
          <a:xfrm>
            <a:off x="3298551" y="1649766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ATG7</a:t>
            </a: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325D2BDA-1430-242D-493E-EC7D1BCB7BF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296" r="12925" b="72389"/>
          <a:stretch>
            <a:fillRect/>
          </a:stretch>
        </p:blipFill>
        <p:spPr>
          <a:xfrm>
            <a:off x="4345577" y="1150482"/>
            <a:ext cx="4746171" cy="1419123"/>
          </a:xfrm>
          <a:prstGeom prst="rect">
            <a:avLst/>
          </a:prstGeom>
        </p:spPr>
      </p:pic>
      <p:sp>
        <p:nvSpPr>
          <p:cNvPr id="39" name="矩形 38">
            <a:extLst>
              <a:ext uri="{FF2B5EF4-FFF2-40B4-BE49-F238E27FC236}">
                <a16:creationId xmlns:a16="http://schemas.microsoft.com/office/drawing/2014/main" id="{ABB3CCC3-E4BB-7C68-6146-463F79074F2C}"/>
              </a:ext>
            </a:extLst>
          </p:cNvPr>
          <p:cNvSpPr/>
          <p:nvPr/>
        </p:nvSpPr>
        <p:spPr>
          <a:xfrm>
            <a:off x="5034057" y="1461564"/>
            <a:ext cx="2636681" cy="73635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" name="图片 3" descr="1125 p62 1 2020.11.25_20.52.23_Ch+Marker">
            <a:extLst>
              <a:ext uri="{FF2B5EF4-FFF2-40B4-BE49-F238E27FC236}">
                <a16:creationId xmlns:a16="http://schemas.microsoft.com/office/drawing/2014/main" id="{E1269539-1B21-C085-3228-DEFEAC4BBEF3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-350" t="12062" r="7716" b="73240"/>
          <a:stretch>
            <a:fillRect/>
          </a:stretch>
        </p:blipFill>
        <p:spPr>
          <a:xfrm>
            <a:off x="4362992" y="2569605"/>
            <a:ext cx="4728756" cy="101890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E58285BE-64EF-4E07-DBE6-6287C7F4025B}"/>
              </a:ext>
            </a:extLst>
          </p:cNvPr>
          <p:cNvSpPr txBox="1"/>
          <p:nvPr/>
        </p:nvSpPr>
        <p:spPr>
          <a:xfrm>
            <a:off x="3399147" y="2991800"/>
            <a:ext cx="5757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P62</a:t>
            </a:r>
          </a:p>
        </p:txBody>
      </p:sp>
      <p:pic>
        <p:nvPicPr>
          <p:cNvPr id="6" name="图片 5" descr="1125 lc3 2 2020.11.25_21.30.04_Ch+Marker">
            <a:extLst>
              <a:ext uri="{FF2B5EF4-FFF2-40B4-BE49-F238E27FC236}">
                <a16:creationId xmlns:a16="http://schemas.microsoft.com/office/drawing/2014/main" id="{30D4DF2D-882A-9155-757C-1C1AE69B7A2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255" t="9302" r="4380" b="69941"/>
          <a:stretch>
            <a:fillRect/>
          </a:stretch>
        </p:blipFill>
        <p:spPr>
          <a:xfrm>
            <a:off x="4423954" y="3565585"/>
            <a:ext cx="4728754" cy="1445622"/>
          </a:xfrm>
          <a:prstGeom prst="rect">
            <a:avLst/>
          </a:prstGeom>
        </p:spPr>
      </p:pic>
      <p:sp>
        <p:nvSpPr>
          <p:cNvPr id="9" name="文本框 30">
            <a:extLst>
              <a:ext uri="{FF2B5EF4-FFF2-40B4-BE49-F238E27FC236}">
                <a16:creationId xmlns:a16="http://schemas.microsoft.com/office/drawing/2014/main" id="{B66444EE-0E38-0DD6-EF4E-16FD0960567A}"/>
              </a:ext>
            </a:extLst>
          </p:cNvPr>
          <p:cNvSpPr txBox="1"/>
          <p:nvPr/>
        </p:nvSpPr>
        <p:spPr>
          <a:xfrm>
            <a:off x="3407162" y="4149168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/>
              <a:t>LC3</a:t>
            </a:r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6390109A-7962-2232-18CA-4153E2D72AB3}"/>
              </a:ext>
            </a:extLst>
          </p:cNvPr>
          <p:cNvSpPr/>
          <p:nvPr/>
        </p:nvSpPr>
        <p:spPr>
          <a:xfrm>
            <a:off x="5141082" y="2759445"/>
            <a:ext cx="2486112" cy="63922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A71E164B-3A44-8E0D-C9F1-09794A9DB242}"/>
              </a:ext>
            </a:extLst>
          </p:cNvPr>
          <p:cNvSpPr/>
          <p:nvPr/>
        </p:nvSpPr>
        <p:spPr>
          <a:xfrm>
            <a:off x="5193333" y="3978339"/>
            <a:ext cx="2486112" cy="63922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417DB0B1-8F0E-D637-308A-E28DDCC36CA2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1874" t="-3768" r="7021" b="89524"/>
          <a:stretch>
            <a:fillRect/>
          </a:stretch>
        </p:blipFill>
        <p:spPr>
          <a:xfrm>
            <a:off x="4423954" y="4740359"/>
            <a:ext cx="4667794" cy="1312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12756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38636A9-91F2-A6ED-D8F7-457E382FAD41}"/>
              </a:ext>
            </a:extLst>
          </p:cNvPr>
          <p:cNvSpPr txBox="1"/>
          <p:nvPr/>
        </p:nvSpPr>
        <p:spPr>
          <a:xfrm>
            <a:off x="742950" y="671513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3</a:t>
            </a:r>
            <a:endParaRPr lang="zh-CN" altLang="en-US" b="1" dirty="0"/>
          </a:p>
        </p:txBody>
      </p:sp>
      <p:pic>
        <p:nvPicPr>
          <p:cNvPr id="2" name="图片 1" descr="0409 phb2  2021.04.08_21.19.24_Ch+Marker">
            <a:extLst>
              <a:ext uri="{FF2B5EF4-FFF2-40B4-BE49-F238E27FC236}">
                <a16:creationId xmlns:a16="http://schemas.microsoft.com/office/drawing/2014/main" id="{D5C68B66-5E4F-38D2-8E2B-4835B8A856AE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rcRect l="18971" t="29013" r="13692" b="53896"/>
          <a:stretch>
            <a:fillRect/>
          </a:stretch>
        </p:blipFill>
        <p:spPr>
          <a:xfrm>
            <a:off x="3741454" y="393880"/>
            <a:ext cx="3709850" cy="1294765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10EC3430-93DA-A244-4CDA-B6311ED54F4A}"/>
              </a:ext>
            </a:extLst>
          </p:cNvPr>
          <p:cNvSpPr txBox="1"/>
          <p:nvPr/>
        </p:nvSpPr>
        <p:spPr>
          <a:xfrm>
            <a:off x="8729327" y="856179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PHB2</a:t>
            </a:r>
          </a:p>
        </p:txBody>
      </p:sp>
      <p:pic>
        <p:nvPicPr>
          <p:cNvPr id="20" name="图片 19" descr="0405 bax 2021.04.05_17.16.13_Ch+Marker">
            <a:extLst>
              <a:ext uri="{FF2B5EF4-FFF2-40B4-BE49-F238E27FC236}">
                <a16:creationId xmlns:a16="http://schemas.microsoft.com/office/drawing/2014/main" id="{12BA8B11-9919-A1B4-145E-4C435B610F76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8761" t="32210" r="23482" b="51191"/>
          <a:stretch>
            <a:fillRect/>
          </a:stretch>
        </p:blipFill>
        <p:spPr>
          <a:xfrm>
            <a:off x="3741454" y="1628023"/>
            <a:ext cx="3709850" cy="109728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3A534557-8D84-3CC8-384B-4A02AC570B91}"/>
              </a:ext>
            </a:extLst>
          </p:cNvPr>
          <p:cNvSpPr txBox="1"/>
          <p:nvPr/>
        </p:nvSpPr>
        <p:spPr>
          <a:xfrm>
            <a:off x="8789130" y="1991997"/>
            <a:ext cx="637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ax</a:t>
            </a:r>
          </a:p>
        </p:txBody>
      </p:sp>
      <p:pic>
        <p:nvPicPr>
          <p:cNvPr id="8" name="图片 7" descr="0412 bcl2 1-1 2021.04.17_16.33.37_Ch+Marker">
            <a:extLst>
              <a:ext uri="{FF2B5EF4-FFF2-40B4-BE49-F238E27FC236}">
                <a16:creationId xmlns:a16="http://schemas.microsoft.com/office/drawing/2014/main" id="{C49185FD-5893-FE71-36F9-791AD5D649F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7934" t="29047" r="9415" b="50878"/>
          <a:stretch>
            <a:fillRect/>
          </a:stretch>
        </p:blipFill>
        <p:spPr>
          <a:xfrm>
            <a:off x="3741453" y="2671399"/>
            <a:ext cx="4621961" cy="139337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C2C86611-C496-96EF-C439-591572B7176B}"/>
              </a:ext>
            </a:extLst>
          </p:cNvPr>
          <p:cNvSpPr txBox="1"/>
          <p:nvPr/>
        </p:nvSpPr>
        <p:spPr>
          <a:xfrm>
            <a:off x="8748563" y="3183418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cl-2</a:t>
            </a:r>
          </a:p>
        </p:txBody>
      </p:sp>
      <p:pic>
        <p:nvPicPr>
          <p:cNvPr id="3" name="图片 2" descr="0520 cas3 phb 2021.05.20_15.20.24_Ch+Marker">
            <a:extLst>
              <a:ext uri="{FF2B5EF4-FFF2-40B4-BE49-F238E27FC236}">
                <a16:creationId xmlns:a16="http://schemas.microsoft.com/office/drawing/2014/main" id="{487F6046-8700-0C1F-BDC8-B0262E0EBD5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2474" t="23364" r="22845" b="61822"/>
          <a:stretch>
            <a:fillRect/>
          </a:stretch>
        </p:blipFill>
        <p:spPr>
          <a:xfrm>
            <a:off x="3741453" y="4064768"/>
            <a:ext cx="3709851" cy="1183728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D440052-0D53-6F3C-7F62-6171FF323124}"/>
              </a:ext>
            </a:extLst>
          </p:cNvPr>
          <p:cNvSpPr txBox="1"/>
          <p:nvPr/>
        </p:nvSpPr>
        <p:spPr>
          <a:xfrm>
            <a:off x="8729327" y="4471966"/>
            <a:ext cx="8597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 Cas-3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2191DEFF-2B3D-3605-2F28-29CB4B9A16C0}"/>
              </a:ext>
            </a:extLst>
          </p:cNvPr>
          <p:cNvSpPr/>
          <p:nvPr/>
        </p:nvSpPr>
        <p:spPr>
          <a:xfrm>
            <a:off x="4353321" y="3075424"/>
            <a:ext cx="2243606" cy="63922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7" name="图片 6" descr="0402 gapdh 1 2021.04.02_22.49.19_Ch+Marker">
            <a:extLst>
              <a:ext uri="{FF2B5EF4-FFF2-40B4-BE49-F238E27FC236}">
                <a16:creationId xmlns:a16="http://schemas.microsoft.com/office/drawing/2014/main" id="{608DA488-1363-F489-929F-16817969804C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4193" t="26136" r="23395" b="56492"/>
          <a:stretch>
            <a:fillRect/>
          </a:stretch>
        </p:blipFill>
        <p:spPr>
          <a:xfrm>
            <a:off x="3741454" y="5229977"/>
            <a:ext cx="3584898" cy="1393370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9A52526F-DDC3-CBCA-72A2-F25FD3A05E61}"/>
              </a:ext>
            </a:extLst>
          </p:cNvPr>
          <p:cNvSpPr txBox="1"/>
          <p:nvPr/>
        </p:nvSpPr>
        <p:spPr>
          <a:xfrm>
            <a:off x="8687778" y="5817155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24382618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610A31-30E7-CF19-FEC7-A61AC3E8941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7A6E04B-BCE7-451D-056F-65E1FC87F9F8}"/>
              </a:ext>
            </a:extLst>
          </p:cNvPr>
          <p:cNvSpPr txBox="1"/>
          <p:nvPr/>
        </p:nvSpPr>
        <p:spPr>
          <a:xfrm>
            <a:off x="742950" y="671513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4</a:t>
            </a:r>
            <a:endParaRPr lang="zh-CN" altLang="en-US" b="1" dirty="0"/>
          </a:p>
        </p:txBody>
      </p:sp>
      <p:pic>
        <p:nvPicPr>
          <p:cNvPr id="7" name="图片 6" descr="0409 lc3 2021.04.08_21.24.34_Ch+Marker">
            <a:extLst>
              <a:ext uri="{FF2B5EF4-FFF2-40B4-BE49-F238E27FC236}">
                <a16:creationId xmlns:a16="http://schemas.microsoft.com/office/drawing/2014/main" id="{F88B3752-AFCD-8812-0596-EDD87F200F5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7569" t="37051" r="15866" b="44503"/>
          <a:stretch>
            <a:fillRect/>
          </a:stretch>
        </p:blipFill>
        <p:spPr>
          <a:xfrm>
            <a:off x="5003045" y="3139353"/>
            <a:ext cx="3709850" cy="1413622"/>
          </a:xfrm>
          <a:prstGeom prst="rect">
            <a:avLst/>
          </a:prstGeom>
        </p:spPr>
      </p:pic>
      <p:sp>
        <p:nvSpPr>
          <p:cNvPr id="24" name="文本框 30">
            <a:extLst>
              <a:ext uri="{FF2B5EF4-FFF2-40B4-BE49-F238E27FC236}">
                <a16:creationId xmlns:a16="http://schemas.microsoft.com/office/drawing/2014/main" id="{9B01FEA4-E2BC-47C1-D8FD-10A775A04F36}"/>
              </a:ext>
            </a:extLst>
          </p:cNvPr>
          <p:cNvSpPr txBox="1"/>
          <p:nvPr/>
        </p:nvSpPr>
        <p:spPr>
          <a:xfrm>
            <a:off x="4227757" y="3661498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/>
              <a:t>LC3</a:t>
            </a:r>
          </a:p>
        </p:txBody>
      </p:sp>
      <p:pic>
        <p:nvPicPr>
          <p:cNvPr id="13" name="图片 12" descr="0411 atg7 4-2 2021.04.11_13.08.31_Ch+Marker">
            <a:extLst>
              <a:ext uri="{FF2B5EF4-FFF2-40B4-BE49-F238E27FC236}">
                <a16:creationId xmlns:a16="http://schemas.microsoft.com/office/drawing/2014/main" id="{184CC1EF-FE2D-E7FD-9E44-52C80E08CBF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1278" t="20193" r="3648" b="65365"/>
          <a:stretch>
            <a:fillRect/>
          </a:stretch>
        </p:blipFill>
        <p:spPr>
          <a:xfrm>
            <a:off x="5033524" y="793301"/>
            <a:ext cx="4991422" cy="993061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C544ABA7-17E5-C761-2FF3-E07AA2C8B1F0}"/>
              </a:ext>
            </a:extLst>
          </p:cNvPr>
          <p:cNvSpPr/>
          <p:nvPr/>
        </p:nvSpPr>
        <p:spPr>
          <a:xfrm>
            <a:off x="5612412" y="948035"/>
            <a:ext cx="2349559" cy="63922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15" name="图片 14" descr="0409 p62 2 2021.04.08_22.20.04_Ch+Marker">
            <a:extLst>
              <a:ext uri="{FF2B5EF4-FFF2-40B4-BE49-F238E27FC236}">
                <a16:creationId xmlns:a16="http://schemas.microsoft.com/office/drawing/2014/main" id="{31B12BC1-F1C6-BEF4-DD87-B89845E3A5C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3027" t="25622" r="12033" b="57061"/>
          <a:stretch>
            <a:fillRect/>
          </a:stretch>
        </p:blipFill>
        <p:spPr>
          <a:xfrm>
            <a:off x="5033524" y="1792341"/>
            <a:ext cx="3648892" cy="1337855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E50D8E6A-FD25-0022-0D00-167BB94733B1}"/>
              </a:ext>
            </a:extLst>
          </p:cNvPr>
          <p:cNvSpPr txBox="1"/>
          <p:nvPr/>
        </p:nvSpPr>
        <p:spPr>
          <a:xfrm>
            <a:off x="4075996" y="2313126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   P62</a:t>
            </a: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965B36F-6B19-3D7C-608D-08A4A7043E93}"/>
              </a:ext>
            </a:extLst>
          </p:cNvPr>
          <p:cNvSpPr txBox="1"/>
          <p:nvPr/>
        </p:nvSpPr>
        <p:spPr>
          <a:xfrm>
            <a:off x="4093786" y="1105165"/>
            <a:ext cx="8194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 ATG7</a:t>
            </a:r>
          </a:p>
        </p:txBody>
      </p:sp>
      <p:pic>
        <p:nvPicPr>
          <p:cNvPr id="20" name="图片 19" descr="0505 gapdh 3-1 2021.05.06_21.49.15_Ch+Marker">
            <a:extLst>
              <a:ext uri="{FF2B5EF4-FFF2-40B4-BE49-F238E27FC236}">
                <a16:creationId xmlns:a16="http://schemas.microsoft.com/office/drawing/2014/main" id="{360D122A-484F-26F8-85AF-D56858A0DAF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1106" t="33207" r="24323" b="52945"/>
          <a:stretch>
            <a:fillRect/>
          </a:stretch>
        </p:blipFill>
        <p:spPr>
          <a:xfrm>
            <a:off x="5003045" y="4394860"/>
            <a:ext cx="3709850" cy="1392444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ED610C33-44DD-64A0-EAD4-3A878A057075}"/>
              </a:ext>
            </a:extLst>
          </p:cNvPr>
          <p:cNvSpPr txBox="1"/>
          <p:nvPr/>
        </p:nvSpPr>
        <p:spPr>
          <a:xfrm>
            <a:off x="3901268" y="4825204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4346574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0AF5267-061D-432D-6F34-60ADF00F531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85C02D85-40C2-56CB-732A-637325C494B3}"/>
              </a:ext>
            </a:extLst>
          </p:cNvPr>
          <p:cNvSpPr txBox="1"/>
          <p:nvPr/>
        </p:nvSpPr>
        <p:spPr>
          <a:xfrm>
            <a:off x="742950" y="671513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5</a:t>
            </a:r>
            <a:endParaRPr lang="zh-CN" altLang="en-US" b="1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6DE2190F-0D2A-542B-3973-E57B927CD878}"/>
              </a:ext>
            </a:extLst>
          </p:cNvPr>
          <p:cNvSpPr txBox="1"/>
          <p:nvPr/>
        </p:nvSpPr>
        <p:spPr>
          <a:xfrm>
            <a:off x="6731334" y="3983117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β-actin</a:t>
            </a:r>
          </a:p>
        </p:txBody>
      </p:sp>
      <p:pic>
        <p:nvPicPr>
          <p:cNvPr id="6" name="图片 5" descr="0328 bcl2 2 2021.03.28_12.10.57_Ch+Marker">
            <a:extLst>
              <a:ext uri="{FF2B5EF4-FFF2-40B4-BE49-F238E27FC236}">
                <a16:creationId xmlns:a16="http://schemas.microsoft.com/office/drawing/2014/main" id="{10E5378A-462A-B92A-C624-FA83D63DD5D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0168" t="27209" r="23825" b="59808"/>
          <a:stretch>
            <a:fillRect/>
          </a:stretch>
        </p:blipFill>
        <p:spPr>
          <a:xfrm>
            <a:off x="7871441" y="959377"/>
            <a:ext cx="3731533" cy="1184080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6C54490A-2F44-75CA-A859-E132171384D9}"/>
              </a:ext>
            </a:extLst>
          </p:cNvPr>
          <p:cNvSpPr txBox="1"/>
          <p:nvPr/>
        </p:nvSpPr>
        <p:spPr>
          <a:xfrm>
            <a:off x="6928553" y="1564155"/>
            <a:ext cx="737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cl-2</a:t>
            </a:r>
          </a:p>
        </p:txBody>
      </p:sp>
      <p:pic>
        <p:nvPicPr>
          <p:cNvPr id="5" name="图片 4" descr="0329 bax 2021.03.29_21.19.24_Ch+Marker">
            <a:extLst>
              <a:ext uri="{FF2B5EF4-FFF2-40B4-BE49-F238E27FC236}">
                <a16:creationId xmlns:a16="http://schemas.microsoft.com/office/drawing/2014/main" id="{C27B38D7-007A-6F9E-4559-1B96E651BFDC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3781" t="29343" r="28063" b="57785"/>
          <a:stretch>
            <a:fillRect/>
          </a:stretch>
        </p:blipFill>
        <p:spPr>
          <a:xfrm>
            <a:off x="7871442" y="2044613"/>
            <a:ext cx="3731532" cy="1281709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68735DE-5E56-DA75-F819-91D576C4CC7E}"/>
              </a:ext>
            </a:extLst>
          </p:cNvPr>
          <p:cNvSpPr txBox="1"/>
          <p:nvPr/>
        </p:nvSpPr>
        <p:spPr>
          <a:xfrm>
            <a:off x="7027693" y="2500802"/>
            <a:ext cx="5597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Bax</a:t>
            </a:r>
          </a:p>
        </p:txBody>
      </p:sp>
      <p:pic>
        <p:nvPicPr>
          <p:cNvPr id="21" name="图片 20" descr="0411 actin1-2 2021.04.11_14.14.24_Ch+Marker">
            <a:extLst>
              <a:ext uri="{FF2B5EF4-FFF2-40B4-BE49-F238E27FC236}">
                <a16:creationId xmlns:a16="http://schemas.microsoft.com/office/drawing/2014/main" id="{18E71782-C87B-484A-CBC6-9D93DA353FE7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14267" t="32306" r="21444" b="54840"/>
          <a:stretch>
            <a:fillRect/>
          </a:stretch>
        </p:blipFill>
        <p:spPr>
          <a:xfrm>
            <a:off x="7871442" y="3570866"/>
            <a:ext cx="3731532" cy="1065855"/>
          </a:xfrm>
          <a:prstGeom prst="rect">
            <a:avLst/>
          </a:prstGeom>
        </p:spPr>
      </p:pic>
      <p:pic>
        <p:nvPicPr>
          <p:cNvPr id="2" name="图片 1" descr="1224 actin2-2 2020.12.24_19.32.44_Ch+Marker">
            <a:extLst>
              <a:ext uri="{FF2B5EF4-FFF2-40B4-BE49-F238E27FC236}">
                <a16:creationId xmlns:a16="http://schemas.microsoft.com/office/drawing/2014/main" id="{38DE905F-E367-5DE0-118C-7B5FEE3E2635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1109" t="8106" r="10474" b="81775"/>
          <a:stretch>
            <a:fillRect/>
          </a:stretch>
        </p:blipFill>
        <p:spPr>
          <a:xfrm>
            <a:off x="1615440" y="2815058"/>
            <a:ext cx="4259580" cy="755808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B171CC5F-427F-0FBF-9AD4-11846E634B98}"/>
              </a:ext>
            </a:extLst>
          </p:cNvPr>
          <p:cNvSpPr txBox="1"/>
          <p:nvPr/>
        </p:nvSpPr>
        <p:spPr>
          <a:xfrm>
            <a:off x="672553" y="2956990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β-actin</a:t>
            </a:r>
          </a:p>
        </p:txBody>
      </p:sp>
      <p:pic>
        <p:nvPicPr>
          <p:cNvPr id="8" name="图片 7" descr="1224 phb2 2 2020.12.24_19.38.07_Ch+Marker">
            <a:extLst>
              <a:ext uri="{FF2B5EF4-FFF2-40B4-BE49-F238E27FC236}">
                <a16:creationId xmlns:a16="http://schemas.microsoft.com/office/drawing/2014/main" id="{AB1EAEC8-B2C0-29E8-B5E2-BB66201AC6D5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11272" t="13732" r="5833" b="77141"/>
          <a:stretch>
            <a:fillRect/>
          </a:stretch>
        </p:blipFill>
        <p:spPr>
          <a:xfrm>
            <a:off x="1615440" y="3630787"/>
            <a:ext cx="4320540" cy="639222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A4F5A521-4FD2-C522-81EF-7F9804CA7589}"/>
              </a:ext>
            </a:extLst>
          </p:cNvPr>
          <p:cNvSpPr txBox="1"/>
          <p:nvPr/>
        </p:nvSpPr>
        <p:spPr>
          <a:xfrm>
            <a:off x="858502" y="3765732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PHB2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F76EE9E7-488B-F3CE-4C52-FDF419D2BFF0}"/>
              </a:ext>
            </a:extLst>
          </p:cNvPr>
          <p:cNvSpPr/>
          <p:nvPr/>
        </p:nvSpPr>
        <p:spPr>
          <a:xfrm>
            <a:off x="3642360" y="3742999"/>
            <a:ext cx="1828800" cy="63922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0472E625-8A5A-4887-0F4C-6E384ABE36CC}"/>
              </a:ext>
            </a:extLst>
          </p:cNvPr>
          <p:cNvSpPr/>
          <p:nvPr/>
        </p:nvSpPr>
        <p:spPr>
          <a:xfrm>
            <a:off x="3642360" y="2819431"/>
            <a:ext cx="1828800" cy="63922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5751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50378266-75C8-18C8-B63B-3FDE8EFF1C7A}"/>
              </a:ext>
            </a:extLst>
          </p:cNvPr>
          <p:cNvSpPr txBox="1"/>
          <p:nvPr/>
        </p:nvSpPr>
        <p:spPr>
          <a:xfrm>
            <a:off x="742950" y="671513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6</a:t>
            </a:r>
            <a:endParaRPr lang="zh-CN" altLang="en-US" b="1" dirty="0"/>
          </a:p>
        </p:txBody>
      </p:sp>
      <p:pic>
        <p:nvPicPr>
          <p:cNvPr id="17" name="图片 16" descr="0530 lc3 1-2 2021.05.30_14.56.36_Ch+Marker">
            <a:extLst>
              <a:ext uri="{FF2B5EF4-FFF2-40B4-BE49-F238E27FC236}">
                <a16:creationId xmlns:a16="http://schemas.microsoft.com/office/drawing/2014/main" id="{A6B2CE0B-4F47-2005-7138-FAD4266B2FC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3247" t="26111" r="23617" b="60523"/>
          <a:stretch>
            <a:fillRect/>
          </a:stretch>
        </p:blipFill>
        <p:spPr>
          <a:xfrm>
            <a:off x="3878174" y="3677419"/>
            <a:ext cx="3162602" cy="1261745"/>
          </a:xfrm>
          <a:prstGeom prst="rect">
            <a:avLst/>
          </a:prstGeom>
        </p:spPr>
      </p:pic>
      <p:sp>
        <p:nvSpPr>
          <p:cNvPr id="18" name="文本框 10">
            <a:extLst>
              <a:ext uri="{FF2B5EF4-FFF2-40B4-BE49-F238E27FC236}">
                <a16:creationId xmlns:a16="http://schemas.microsoft.com/office/drawing/2014/main" id="{4EE81E5D-7A28-6797-3935-AF23AF503F35}"/>
              </a:ext>
            </a:extLst>
          </p:cNvPr>
          <p:cNvSpPr txBox="1"/>
          <p:nvPr/>
        </p:nvSpPr>
        <p:spPr>
          <a:xfrm>
            <a:off x="3114569" y="4123625"/>
            <a:ext cx="8652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b="1" dirty="0"/>
              <a:t>LC3</a:t>
            </a:r>
          </a:p>
        </p:txBody>
      </p:sp>
      <p:pic>
        <p:nvPicPr>
          <p:cNvPr id="21" name="图片 20" descr="0530 atg7 2 2021.05.30_15.08.53_Ch+Marker">
            <a:extLst>
              <a:ext uri="{FF2B5EF4-FFF2-40B4-BE49-F238E27FC236}">
                <a16:creationId xmlns:a16="http://schemas.microsoft.com/office/drawing/2014/main" id="{C2D45A10-B9CC-1E09-CEF2-815F25C6F7D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7805" t="29235" r="7434" b="55470"/>
          <a:stretch>
            <a:fillRect/>
          </a:stretch>
        </p:blipFill>
        <p:spPr>
          <a:xfrm>
            <a:off x="3878174" y="2543778"/>
            <a:ext cx="3495859" cy="1123552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F01FDE41-1106-4BFE-BE6D-8C6DADC5287C}"/>
              </a:ext>
            </a:extLst>
          </p:cNvPr>
          <p:cNvSpPr txBox="1"/>
          <p:nvPr/>
        </p:nvSpPr>
        <p:spPr>
          <a:xfrm>
            <a:off x="2970699" y="2988154"/>
            <a:ext cx="107378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TG7</a:t>
            </a:r>
          </a:p>
        </p:txBody>
      </p:sp>
      <p:pic>
        <p:nvPicPr>
          <p:cNvPr id="5" name="图片 4" descr="0328 gapdh 1 2021.03.28_12.38.49_Ch+Marker">
            <a:extLst>
              <a:ext uri="{FF2B5EF4-FFF2-40B4-BE49-F238E27FC236}">
                <a16:creationId xmlns:a16="http://schemas.microsoft.com/office/drawing/2014/main" id="{15F16063-B1D2-CDBD-A868-4DA15358ED8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22986" t="21828" r="16445" b="61389"/>
          <a:stretch>
            <a:fillRect/>
          </a:stretch>
        </p:blipFill>
        <p:spPr>
          <a:xfrm>
            <a:off x="3979811" y="4949253"/>
            <a:ext cx="3060965" cy="116631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F0AD0EA6-6E64-7198-266B-3FD21A9A1BC8}"/>
              </a:ext>
            </a:extLst>
          </p:cNvPr>
          <p:cNvSpPr txBox="1"/>
          <p:nvPr/>
        </p:nvSpPr>
        <p:spPr>
          <a:xfrm>
            <a:off x="2908037" y="5465926"/>
            <a:ext cx="9701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GAPDH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94961921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BA50B3D1-55E8-0E1B-D815-AA541E2F2FEF}"/>
              </a:ext>
            </a:extLst>
          </p:cNvPr>
          <p:cNvSpPr txBox="1"/>
          <p:nvPr/>
        </p:nvSpPr>
        <p:spPr>
          <a:xfrm>
            <a:off x="742950" y="671513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7</a:t>
            </a:r>
            <a:endParaRPr lang="zh-CN" altLang="en-US" b="1" dirty="0"/>
          </a:p>
        </p:txBody>
      </p:sp>
      <p:pic>
        <p:nvPicPr>
          <p:cNvPr id="5" name="图片 4" descr="0220 actin1-1 2021.02.20_20.41.13_Ch+Marker">
            <a:extLst>
              <a:ext uri="{FF2B5EF4-FFF2-40B4-BE49-F238E27FC236}">
                <a16:creationId xmlns:a16="http://schemas.microsoft.com/office/drawing/2014/main" id="{51EADB98-4402-7B83-8182-BF40BA06426C}"/>
              </a:ext>
            </a:extLst>
          </p:cNvPr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3"/>
          <a:srcRect l="6749" t="43487" r="6086" b="45806"/>
          <a:stretch>
            <a:fillRect/>
          </a:stretch>
        </p:blipFill>
        <p:spPr>
          <a:xfrm>
            <a:off x="3591877" y="3718560"/>
            <a:ext cx="5008245" cy="84582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374ABA03-F188-B241-D846-7817E6939CEC}"/>
              </a:ext>
            </a:extLst>
          </p:cNvPr>
          <p:cNvSpPr txBox="1"/>
          <p:nvPr/>
        </p:nvSpPr>
        <p:spPr>
          <a:xfrm>
            <a:off x="2408555" y="3938270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β-actin</a:t>
            </a:r>
          </a:p>
        </p:txBody>
      </p:sp>
      <p:pic>
        <p:nvPicPr>
          <p:cNvPr id="7" name="图片 6" descr="0220 phb2 2021.02.20_20.44.10_Ch+Marker">
            <a:extLst>
              <a:ext uri="{FF2B5EF4-FFF2-40B4-BE49-F238E27FC236}">
                <a16:creationId xmlns:a16="http://schemas.microsoft.com/office/drawing/2014/main" id="{8DC511B4-87BD-3259-C8B7-D97C05A705C8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665" t="43883" r="9837" b="46964"/>
          <a:stretch>
            <a:fillRect/>
          </a:stretch>
        </p:blipFill>
        <p:spPr>
          <a:xfrm>
            <a:off x="3591877" y="2709544"/>
            <a:ext cx="4886960" cy="719456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28D511EA-8013-2DA6-ED35-2A2C16EF6C82}"/>
              </a:ext>
            </a:extLst>
          </p:cNvPr>
          <p:cNvSpPr txBox="1"/>
          <p:nvPr/>
        </p:nvSpPr>
        <p:spPr>
          <a:xfrm>
            <a:off x="2500630" y="3051810"/>
            <a:ext cx="756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/>
              <a:t>PHB2</a:t>
            </a: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E3404276-E17C-932C-8C44-662E2BA0D386}"/>
              </a:ext>
            </a:extLst>
          </p:cNvPr>
          <p:cNvSpPr/>
          <p:nvPr/>
        </p:nvSpPr>
        <p:spPr>
          <a:xfrm>
            <a:off x="5499734" y="2744980"/>
            <a:ext cx="2249805" cy="64858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968D05BD-D65E-F799-FF9C-4BC756D9CC8E}"/>
              </a:ext>
            </a:extLst>
          </p:cNvPr>
          <p:cNvSpPr/>
          <p:nvPr/>
        </p:nvSpPr>
        <p:spPr>
          <a:xfrm>
            <a:off x="5575934" y="3983310"/>
            <a:ext cx="2249805" cy="64858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499100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0102 lc3 1-2 2021.01.02_17.20.02_Ch+Marker">
            <a:extLst>
              <a:ext uri="{FF2B5EF4-FFF2-40B4-BE49-F238E27FC236}">
                <a16:creationId xmlns:a16="http://schemas.microsoft.com/office/drawing/2014/main" id="{A49F77ED-EEDE-CBD0-5656-C4D47E8BC00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4003" t="3581" r="3687" b="82412"/>
          <a:stretch>
            <a:fillRect/>
          </a:stretch>
        </p:blipFill>
        <p:spPr>
          <a:xfrm>
            <a:off x="3139440" y="3966085"/>
            <a:ext cx="4998720" cy="1169795"/>
          </a:xfrm>
          <a:prstGeom prst="rect">
            <a:avLst/>
          </a:prstGeom>
        </p:spPr>
      </p:pic>
      <p:pic>
        <p:nvPicPr>
          <p:cNvPr id="5" name="图片 4" descr="0102 actin3-1 2021.01.02_16.08.20_Ch+Marker">
            <a:extLst>
              <a:ext uri="{FF2B5EF4-FFF2-40B4-BE49-F238E27FC236}">
                <a16:creationId xmlns:a16="http://schemas.microsoft.com/office/drawing/2014/main" id="{7BC067FE-2A99-5347-B2FD-56F1B9B36C7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021" t="7512" r="8292" b="82784"/>
          <a:stretch>
            <a:fillRect/>
          </a:stretch>
        </p:blipFill>
        <p:spPr>
          <a:xfrm>
            <a:off x="3139440" y="3220719"/>
            <a:ext cx="5105399" cy="745366"/>
          </a:xfrm>
          <a:prstGeom prst="rect">
            <a:avLst/>
          </a:prstGeom>
        </p:spPr>
      </p:pic>
      <p:sp>
        <p:nvSpPr>
          <p:cNvPr id="9" name="矩形 8">
            <a:extLst>
              <a:ext uri="{FF2B5EF4-FFF2-40B4-BE49-F238E27FC236}">
                <a16:creationId xmlns:a16="http://schemas.microsoft.com/office/drawing/2014/main" id="{48933D76-6A74-2390-D95B-2FED90256512}"/>
              </a:ext>
            </a:extLst>
          </p:cNvPr>
          <p:cNvSpPr/>
          <p:nvPr/>
        </p:nvSpPr>
        <p:spPr>
          <a:xfrm>
            <a:off x="3716655" y="3264976"/>
            <a:ext cx="1714500" cy="648583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" name="矩形 9">
            <a:extLst>
              <a:ext uri="{FF2B5EF4-FFF2-40B4-BE49-F238E27FC236}">
                <a16:creationId xmlns:a16="http://schemas.microsoft.com/office/drawing/2014/main" id="{3E63F37B-8D8C-73C1-3F25-BDB70CB88508}"/>
              </a:ext>
            </a:extLst>
          </p:cNvPr>
          <p:cNvSpPr/>
          <p:nvPr/>
        </p:nvSpPr>
        <p:spPr>
          <a:xfrm>
            <a:off x="3550920" y="4186430"/>
            <a:ext cx="1943100" cy="736090"/>
          </a:xfrm>
          <a:prstGeom prst="rect">
            <a:avLst/>
          </a:prstGeom>
          <a:noFill/>
          <a:ln w="38100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D9BAFC91-E45D-2EDC-AAA4-7E5BA8F50FFC}"/>
              </a:ext>
            </a:extLst>
          </p:cNvPr>
          <p:cNvSpPr txBox="1"/>
          <p:nvPr/>
        </p:nvSpPr>
        <p:spPr>
          <a:xfrm>
            <a:off x="742950" y="671513"/>
            <a:ext cx="10358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8</a:t>
            </a:r>
            <a:endParaRPr lang="zh-CN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DEE3B6C-7F35-237C-E9D0-F4304BE96FB1}"/>
              </a:ext>
            </a:extLst>
          </p:cNvPr>
          <p:cNvSpPr txBox="1"/>
          <p:nvPr/>
        </p:nvSpPr>
        <p:spPr>
          <a:xfrm>
            <a:off x="2493504" y="4288909"/>
            <a:ext cx="5677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LC3</a:t>
            </a:r>
            <a:endParaRPr lang="zh-CN" altLang="en-US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2725C75-5CB6-20B0-ECA5-176B795AC36E}"/>
              </a:ext>
            </a:extLst>
          </p:cNvPr>
          <p:cNvSpPr txBox="1"/>
          <p:nvPr/>
        </p:nvSpPr>
        <p:spPr>
          <a:xfrm>
            <a:off x="2118401" y="3343641"/>
            <a:ext cx="9428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β-actin</a:t>
            </a:r>
          </a:p>
        </p:txBody>
      </p:sp>
    </p:spTree>
    <p:extLst>
      <p:ext uri="{BB962C8B-B14F-4D97-AF65-F5344CB8AC3E}">
        <p14:creationId xmlns:p14="http://schemas.microsoft.com/office/powerpoint/2010/main" val="389228547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6457,&quot;width&quot;:4696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6457,&quot;width&quot;:4696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12</TotalTime>
  <Words>55</Words>
  <Application>Microsoft Office PowerPoint</Application>
  <PresentationFormat>宽屏</PresentationFormat>
  <Paragraphs>43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 zhang</dc:creator>
  <cp:lastModifiedBy>qi zhang</cp:lastModifiedBy>
  <cp:revision>107</cp:revision>
  <dcterms:created xsi:type="dcterms:W3CDTF">2025-07-06T11:54:23Z</dcterms:created>
  <dcterms:modified xsi:type="dcterms:W3CDTF">2025-11-15T02:04:15Z</dcterms:modified>
</cp:coreProperties>
</file>